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609480" y="368136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623160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431928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802872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60948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431928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802872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609480" y="272520"/>
            <a:ext cx="109713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Bef>
                <a:spcPts val="1426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623160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 fontScale="92000"/>
          </a:bodyPr>
          <a:p>
            <a:pPr marL="315360" indent="0">
              <a:lnSpc>
                <a:spcPct val="93000"/>
              </a:lnSpc>
              <a:spcBef>
                <a:spcPts val="1426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8" name=""/>
          <p:cNvGraphicFramePr/>
          <p:nvPr/>
        </p:nvGraphicFramePr>
        <p:xfrm>
          <a:off x="3792600" y="260280"/>
          <a:ext cx="4753080" cy="6278760"/>
        </p:xfrm>
        <a:graphic>
          <a:graphicData uri="http://schemas.openxmlformats.org/drawingml/2006/table">
            <a:tbl>
              <a:tblPr/>
              <a:tblGrid>
                <a:gridCol w="1280880"/>
                <a:gridCol w="1743120"/>
                <a:gridCol w="1729080"/>
              </a:tblGrid>
              <a:tr h="717480"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Gene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(UCSC REFGENE NAME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Target I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from 450K array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      </a:t>
                      </a: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pGs around Target I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17840"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LEF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9737633 (</a:t>
                      </a:r>
                      <a:r>
                        <a:rPr b="1" lang="es-E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2</a:t>
                      </a:r>
                      <a:r>
                        <a:rPr b="0" lang="es-E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       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chr4: 10908793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2        chr4: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090879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3        chr4: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0908789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17480"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HOXA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4013695 (</a:t>
                      </a: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3</a:t>
                      </a: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);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6997642 (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CG5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)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</a:rPr>
                        <a:t>CG3        chr7: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1842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</a:rPr>
                        <a:t>CG4        chr7: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1842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5        chr7: 2718421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17480"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EVC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06426416 (</a:t>
                      </a: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3</a:t>
                      </a: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        chr4: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571037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2        chr4: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571037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3        chr4: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571038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96760"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DKL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0344081 (</a:t>
                      </a: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2</a:t>
                      </a: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);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4263942 (</a:t>
                      </a: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3</a:t>
                      </a: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        chr4: 7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655574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2        chr4: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7655574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3        chr4: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7655575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CG4        chr4: 7655575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97120"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TLX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8336674 (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CG4</a:t>
                      </a: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        chr5: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7073523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2        chr5: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7073523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3        chr5:</a:t>
                      </a: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7073524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CG4        chr5: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7073526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38200"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FERD3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0043037 (</a:t>
                      </a: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3</a:t>
                      </a: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        chr7: 191854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2        chr7: 191854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3        chr7: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1918540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8560"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HL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02</a:t>
                      </a:r>
                      <a:r>
                        <a:rPr b="0" lang="es-E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08485 (</a:t>
                      </a:r>
                      <a:r>
                        <a:rPr b="1" lang="es-E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1</a:t>
                      </a:r>
                      <a:r>
                        <a:rPr b="0" lang="es-E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 algn="just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</a:rPr>
                        <a:t>CG1        chr3: 350602</a:t>
                      </a:r>
                      <a:r>
                        <a:rPr b="1" lang="en-US" sz="1100" spc="-1" strike="noStrike">
                          <a:solidFill>
                            <a:srgbClr val="ff0000"/>
                          </a:solidFill>
                          <a:latin typeface="Calibri"/>
                        </a:rPr>
                        <a:t>     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0000"/>
                          </a:solidFill>
                          <a:latin typeface="Calibri"/>
                        </a:rPr>
                        <a:t>            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17840"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TRIP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02085507 (</a:t>
                      </a:r>
                      <a:r>
                        <a:rPr b="1" lang="es-E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5</a:t>
                      </a:r>
                      <a:r>
                        <a:rPr b="0" lang="es-E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5200" rIns="252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3        chr19: 673918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4        chr19: 673919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a"/>
                          </a:solidFill>
                          <a:latin typeface="Calibri"/>
                          <a:ea typeface="Calibri"/>
                        </a:rPr>
                        <a:t>CG5        chr19: 673919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25200" marR="25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9" name="Rectangle 5"/>
          <p:cNvSpPr/>
          <p:nvPr/>
        </p:nvSpPr>
        <p:spPr>
          <a:xfrm>
            <a:off x="192240" y="2916360"/>
            <a:ext cx="3311280" cy="94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Table S4: </a:t>
            </a:r>
            <a:r>
              <a:rPr b="0" lang="es-ES" sz="1100" spc="-1" strike="noStrike">
                <a:solidFill>
                  <a:srgbClr val="000000"/>
                </a:solidFill>
                <a:latin typeface="Calibri"/>
              </a:rPr>
              <a:t>CpGs studied by pyrosequencing in the  DC and in the VC to validate methylation in the candidate genes 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identified in the 450k array (Illumina). In bold, CpGs from 450k array. Normal type, consecutive CpGs.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2-11T16:19:16Z</dcterms:created>
  <dc:creator>Angel Diaz Lagares</dc:creator>
  <dc:description/>
  <dc:language>en-US</dc:language>
  <cp:lastModifiedBy>JABELLA</cp:lastModifiedBy>
  <cp:lastPrinted>2018-04-16T13:28:07Z</cp:lastPrinted>
  <dcterms:modified xsi:type="dcterms:W3CDTF">2019-02-01T22:50:26Z</dcterms:modified>
  <cp:revision>175</cp:revision>
  <dc:subject/>
  <dc:title>Presentación de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HiddenSlides">
    <vt:r8>0</vt:r8>
  </property>
  <property fmtid="{D5CDD505-2E9C-101B-9397-08002B2CF9AE}" pid="3" name="HyperlinksChanged">
    <vt:bool>0</vt:bool>
  </property>
  <property fmtid="{D5CDD505-2E9C-101B-9397-08002B2CF9AE}" pid="4" name="LinksUpToDate">
    <vt:bool>0</vt:bool>
  </property>
  <property fmtid="{D5CDD505-2E9C-101B-9397-08002B2CF9AE}" pid="5" name="MMClips">
    <vt:r8>0</vt:r8>
  </property>
  <property fmtid="{D5CDD505-2E9C-101B-9397-08002B2CF9AE}" pid="6" name="Notes">
    <vt:r8>0</vt:r8>
  </property>
  <property fmtid="{D5CDD505-2E9C-101B-9397-08002B2CF9AE}" pid="7" name="PresentationFormat">
    <vt:lpwstr>Panorámica</vt:lpwstr>
  </property>
  <property fmtid="{D5CDD505-2E9C-101B-9397-08002B2CF9AE}" pid="8" name="ScaleCrop">
    <vt:bool>0</vt:bool>
  </property>
  <property fmtid="{D5CDD505-2E9C-101B-9397-08002B2CF9AE}" pid="9" name="ShareDoc">
    <vt:bool>0</vt:bool>
  </property>
  <property fmtid="{D5CDD505-2E9C-101B-9397-08002B2CF9AE}" pid="10" name="Slides">
    <vt:r8>18</vt:r8>
  </property>
</Properties>
</file>